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2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3" r:id="rId16"/>
    <p:sldId id="274" r:id="rId17"/>
    <p:sldId id="275" r:id="rId18"/>
    <p:sldId id="271" r:id="rId19"/>
    <p:sldId id="272" r:id="rId20"/>
    <p:sldId id="276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797"/>
    <p:restoredTop sz="94665"/>
  </p:normalViewPr>
  <p:slideViewPr>
    <p:cSldViewPr snapToGrid="0" snapToObjects="1">
      <p:cViewPr varScale="1">
        <p:scale>
          <a:sx n="68" d="100"/>
          <a:sy n="68" d="100"/>
        </p:scale>
        <p:origin x="216" y="10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9A3508-53E9-5546-95E6-5B32B11A89CD}" type="datetimeFigureOut">
              <a:rPr lang="en-US" smtClean="0"/>
              <a:t>7/2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96D13C-CC61-A24C-8822-AD60AA269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2163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96D13C-CC61-A24C-8822-AD60AA269C22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063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F70CCC-A1BB-6345-B478-9C1B51237C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D8E506-FFEF-5B48-969A-01E5A27494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C13104-B256-B646-9533-BA10A8D640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012ECC-7A9E-4943-81EB-7905AEA57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1021DC-7117-F744-9D87-C855561AC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751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697959-3099-FE4E-9F01-B25C4BD629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1D62B1-4766-D944-AFCD-EAD8DFC251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B1B392-E9E4-6447-857B-0F5880515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D011FB-2418-5D4A-AB3F-06447D1558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21819-2298-0E4D-80F1-AB1152861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481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8670D38-1A86-6C42-952D-148977EAE2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928F19-532D-E44B-9F1E-F62445BA1C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BC3D8C-6402-A741-AEE4-D10CCE61D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FFF59E-43E0-F34F-B10C-7E70070B33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7FA673-136D-0841-8E33-D3A054E8D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214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AE7C51-D42A-8346-93F7-4402CC6BD0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69ADDD-9EF0-9C43-8ABE-2A1038126D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4B330-6D46-9549-B8CE-FE430A6F7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E65AEE-34CF-CC42-98E3-F114176E02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B91B9-84B3-2347-B71C-A48685822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108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E7C9D-2B2A-3F4C-BED7-EF01FBED5D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AEF3AC-935A-6F49-B131-D0B2951006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7B1C05-7C99-2B47-B84B-4B678AD32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778624-6718-C243-B812-50407F71F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33545E-4B70-FA42-BBF6-80ABB259C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850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B808BE-B09D-DB47-92DF-BA114977D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C6B281-918F-3846-85B0-9A68C2118D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59BB07-6A8D-744A-BE13-9D7683E5B4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757F7D-EB64-2B4C-878C-99125295C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CF1B8D-C9BB-424A-BC26-ADE5FD1DAC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91F34E-2F41-E04D-839C-C8B876DF4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296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29490A-6921-C948-BF04-537DAFE75C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E22004-5B77-DD45-92F2-19422D9678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5E9569-6BC8-1B47-B8AD-1E9553A6F2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333537B-FF5D-7E48-9A90-61D47A429C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D9A44D-E0A0-3B42-86CA-CDE0CD1F5C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B863CD-6A9A-F441-BCAD-83E636A48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9D65480-8C41-F94D-9C60-5F88B5E2EE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80B98FE-AC69-3145-8DBA-418033D8E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997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9F3644-FA67-DD48-98CF-BD68C75322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4E409B-643A-CC4A-97B9-31C8877506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200285E-3058-3D4D-B4EE-EEB6FE7FDE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41A508-5A9A-1B41-9EBE-11A9D9D39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308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7BA02D5-F190-7E4A-93CC-486BF564C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3B5551-4028-724D-8634-7CBCA47A2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92CD14C-003F-2B4B-BFB4-89618F722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054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F3FA74-91DD-8741-9D36-FA965C898E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A7C2D7-5F8C-4B4A-B882-2575155CB7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0572A4-3223-8949-83F1-DA1837CA8B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D224AF-C468-2241-B663-8CF23F26F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F1B4BB-0A49-224A-AC3B-AF9769554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5D018F-9D44-DA43-8469-755CFFDB9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654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2FE782-36BD-7542-8E3B-3EDDDFBF81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684158-87EF-4340-A0E3-1851FB8A8A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CF284D-C468-CC44-8E9E-CC9BDE8400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59FBBB-EDEF-5344-AADF-652E99FBA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5C4574-C2BB-EA49-AB25-1F57D5ADFE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F9BFA1-7BA4-644A-AE8A-84BEE8D8C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510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EAE82E7-E63E-B44C-8FAA-7836C30B39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3B1B34-43B4-B845-8231-09F7CEDE6E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FC8B80-F518-BB4C-BCD8-842DF7400B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162718-743E-1D4E-85E8-603915743FCB}" type="datetimeFigureOut">
              <a:rPr lang="en-US" smtClean="0"/>
              <a:t>7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93BE2A-C599-C040-8D28-D43796A983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4F0654-306F-074C-9F7F-21E9AE5133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0FF9F5-5004-F24F-B669-9FE030610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341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B33235-CEFE-5B43-A80F-2482BBF2BD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 (CBC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3BCD9B-1A8A-B14C-BFEF-7FC7825828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White blood count (WBC) 		12.9 x1000/mm</a:t>
            </a:r>
            <a:r>
              <a:rPr lang="en-US" baseline="30000" dirty="0"/>
              <a:t>3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Hemoglobin (Hgb)				9.7 g/dL</a:t>
            </a:r>
          </a:p>
          <a:p>
            <a:pPr marL="0" indent="0">
              <a:buNone/>
            </a:pPr>
            <a:r>
              <a:rPr lang="en-US" dirty="0"/>
              <a:t>Hematocrit (HCT)				24.6%</a:t>
            </a:r>
          </a:p>
          <a:p>
            <a:pPr marL="0" indent="0">
              <a:buNone/>
            </a:pPr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 				95 x1000/mm</a:t>
            </a:r>
            <a:r>
              <a:rPr lang="en-US" baseline="30000" dirty="0"/>
              <a:t>3</a:t>
            </a:r>
            <a:r>
              <a:rPr lang="en-US" dirty="0"/>
              <a:t> </a:t>
            </a:r>
          </a:p>
          <a:p>
            <a:pPr marL="0" indent="0">
              <a:buNone/>
            </a:pPr>
            <a:r>
              <a:rPr lang="en-US" dirty="0"/>
              <a:t>Diff						pending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692447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AA658-4769-EF43-8B86-F19F4D238A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est radiograph (CXR)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D4D314-DFEC-B24B-8D82-217A6E2FC0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No acute disease in the chest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02928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5402F9-650A-044C-97A2-EC82515469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gnesium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61F56A-4833-394A-9EDA-55EB22CA03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1.8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</p:txBody>
      </p:sp>
    </p:spTree>
    <p:extLst>
      <p:ext uri="{BB962C8B-B14F-4D97-AF65-F5344CB8AC3E}">
        <p14:creationId xmlns:p14="http://schemas.microsoft.com/office/powerpoint/2010/main" val="370404699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D045C7-91B1-2745-92A6-ABDC5B347F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rain computed tomography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58561C-2CFF-6548-8B46-6B3E220E31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No acute intracranial abnormalities </a:t>
            </a:r>
          </a:p>
        </p:txBody>
      </p:sp>
    </p:spTree>
    <p:extLst>
      <p:ext uri="{BB962C8B-B14F-4D97-AF65-F5344CB8AC3E}">
        <p14:creationId xmlns:p14="http://schemas.microsoft.com/office/powerpoint/2010/main" val="349247728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F800D6-08E7-754A-AF57-4519A452D6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c Aci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29B3BC-15F8-4D45-9972-4436AC4D9E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ending</a:t>
            </a:r>
          </a:p>
        </p:txBody>
      </p:sp>
    </p:spTree>
    <p:extLst>
      <p:ext uri="{BB962C8B-B14F-4D97-AF65-F5344CB8AC3E}">
        <p14:creationId xmlns:p14="http://schemas.microsoft.com/office/powerpoint/2010/main" val="402839103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77BBA2-7678-CF49-BE32-34A2DB3A15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Haptaglobin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052318-CBC2-8D48-8B3F-8D7FB5EE2F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ending</a:t>
            </a:r>
          </a:p>
        </p:txBody>
      </p:sp>
    </p:spTree>
    <p:extLst>
      <p:ext uri="{BB962C8B-B14F-4D97-AF65-F5344CB8AC3E}">
        <p14:creationId xmlns:p14="http://schemas.microsoft.com/office/powerpoint/2010/main" val="340503425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233EC5-1C17-1A46-85EC-0760DF2FE2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ctic aci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17F416-A151-784D-A304-A6FF58BBBC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6.6 mmol/L</a:t>
            </a:r>
          </a:p>
        </p:txBody>
      </p:sp>
    </p:spTree>
    <p:extLst>
      <p:ext uri="{BB962C8B-B14F-4D97-AF65-F5344CB8AC3E}">
        <p14:creationId xmlns:p14="http://schemas.microsoft.com/office/powerpoint/2010/main" val="243355287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765FE-4663-BD4A-8B17-29FDA4B4DD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peat Magnesium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A14EB5-32BD-CE49-8A44-30795343FB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ending </a:t>
            </a:r>
          </a:p>
        </p:txBody>
      </p:sp>
    </p:spTree>
    <p:extLst>
      <p:ext uri="{BB962C8B-B14F-4D97-AF65-F5344CB8AC3E}">
        <p14:creationId xmlns:p14="http://schemas.microsoft.com/office/powerpoint/2010/main" val="299817241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0B459E-44EB-DD4F-882E-9B97D5AACE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peat lactic aci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19BAE-72B2-BC43-9475-3F328DB09E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1.8 mmol/L</a:t>
            </a:r>
          </a:p>
        </p:txBody>
      </p:sp>
    </p:spTree>
    <p:extLst>
      <p:ext uri="{BB962C8B-B14F-4D97-AF65-F5344CB8AC3E}">
        <p14:creationId xmlns:p14="http://schemas.microsoft.com/office/powerpoint/2010/main" val="33996295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23714-39E8-0242-8BA3-BB070912E0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rrival electrocardiogram (EKG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BCDB9D-A8F7-7848-B034-070715CC04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File NSR (</a:t>
            </a:r>
            <a:r>
              <a:rPr lang="en-US" dirty="0" err="1"/>
              <a:t>CardioNetworks</a:t>
            </a:r>
            <a:r>
              <a:rPr lang="en-US" dirty="0"/>
              <a:t> </a:t>
            </a:r>
            <a:r>
              <a:rPr lang="en-US" dirty="0" err="1"/>
              <a:t>ECGpedia</a:t>
            </a:r>
            <a:r>
              <a:rPr lang="en-US" dirty="0"/>
              <a:t>) is licensed under creative commons attribution-share alike 3.0 imported (CC BY-SA 3.0)</a:t>
            </a:r>
          </a:p>
          <a:p>
            <a:pPr marL="0" indent="0">
              <a:buNone/>
            </a:pPr>
            <a:endParaRPr lang="en-US" dirty="0"/>
          </a:p>
        </p:txBody>
      </p:sp>
      <p:pic>
        <p:nvPicPr>
          <p:cNvPr id="4" name="Picture 3" descr="A picture containing tennis, text&#10;&#10;Description automatically generated">
            <a:extLst>
              <a:ext uri="{FF2B5EF4-FFF2-40B4-BE49-F238E27FC236}">
                <a16:creationId xmlns:a16="http://schemas.microsoft.com/office/drawing/2014/main" id="{CF7FDCEE-88EA-B744-A555-072D8DF154F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200400" y="2667000"/>
            <a:ext cx="5791200" cy="3981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773210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8AC748-4FED-9242-A7AD-67C204D269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st-magnesium electrocardiogram (EKG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EDCB92-B963-7C4B-AEC0-88FE3D6BC7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pic>
        <p:nvPicPr>
          <p:cNvPr id="4" name="Picture 3" descr="A picture containing shape&#10;&#10;Description automatically generated">
            <a:extLst>
              <a:ext uri="{FF2B5EF4-FFF2-40B4-BE49-F238E27FC236}">
                <a16:creationId xmlns:a16="http://schemas.microsoft.com/office/drawing/2014/main" id="{5FD36735-F6A3-B841-BC2C-4136BEF7193B}"/>
              </a:ext>
            </a:extLst>
          </p:cNvPr>
          <p:cNvPicPr/>
          <p:nvPr/>
        </p:nvPicPr>
        <p:blipFill rotWithShape="1">
          <a:blip r:embed="rId2"/>
          <a:srcRect l="4511" t="8017" r="4491" b="6352"/>
          <a:stretch/>
        </p:blipFill>
        <p:spPr bwMode="auto">
          <a:xfrm>
            <a:off x="2266950" y="2021204"/>
            <a:ext cx="7239000" cy="401764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40628901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92FB7D-35B0-D443-8A09-16A1759A22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metabolic panel (CMP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EBB42F-5753-B042-B3ED-3E9065A714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55000" lnSpcReduction="20000"/>
          </a:bodyPr>
          <a:lstStyle/>
          <a:p>
            <a:pPr marL="0" indent="0">
              <a:buNone/>
            </a:pPr>
            <a:r>
              <a:rPr lang="en-US" dirty="0"/>
              <a:t>Sodium 					136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Chloride  					108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Potassium					3.8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Bicarbonate (HCO</a:t>
            </a:r>
            <a:r>
              <a:rPr lang="en-US" baseline="-25000" dirty="0"/>
              <a:t>3</a:t>
            </a:r>
            <a:r>
              <a:rPr lang="en-US" dirty="0"/>
              <a:t>)				28 </a:t>
            </a:r>
            <a:r>
              <a:rPr lang="en-US" dirty="0" err="1"/>
              <a:t>mEq</a:t>
            </a:r>
            <a:r>
              <a:rPr lang="en-US" dirty="0"/>
              <a:t>/L </a:t>
            </a:r>
          </a:p>
          <a:p>
            <a:pPr marL="0" indent="0">
              <a:buNone/>
            </a:pPr>
            <a:r>
              <a:rPr lang="en-US" dirty="0"/>
              <a:t>Blood Urea Nitrogen (BUN)			24 mg/dL  </a:t>
            </a:r>
          </a:p>
          <a:p>
            <a:pPr marL="0" indent="0">
              <a:buNone/>
            </a:pPr>
            <a:r>
              <a:rPr lang="en-US" dirty="0"/>
              <a:t>Creatine (Cr)		 		1.8 mg/dL </a:t>
            </a:r>
          </a:p>
          <a:p>
            <a:pPr marL="0" indent="0">
              <a:buNone/>
            </a:pPr>
            <a:r>
              <a:rPr lang="en-US" dirty="0"/>
              <a:t>Glucose 					98 mg/dL</a:t>
            </a:r>
          </a:p>
          <a:p>
            <a:pPr marL="0" indent="0">
              <a:buNone/>
            </a:pPr>
            <a:r>
              <a:rPr lang="en-US" dirty="0"/>
              <a:t>Calcium					9.2 mg/dL</a:t>
            </a:r>
          </a:p>
          <a:p>
            <a:pPr marL="0" indent="0">
              <a:buNone/>
            </a:pPr>
            <a:r>
              <a:rPr lang="en-US" dirty="0"/>
              <a:t>Total bilirubin				1.3 mg/dL</a:t>
            </a:r>
          </a:p>
          <a:p>
            <a:pPr marL="0" indent="0">
              <a:buNone/>
            </a:pPr>
            <a:r>
              <a:rPr lang="en-US" dirty="0"/>
              <a:t>Direct bilirubin				0.8 mg/dL</a:t>
            </a:r>
          </a:p>
          <a:p>
            <a:pPr marL="0" indent="0">
              <a:buNone/>
            </a:pPr>
            <a:r>
              <a:rPr lang="en-US" dirty="0"/>
              <a:t>Indirect bilirubin				0.3 mg/dL</a:t>
            </a:r>
          </a:p>
          <a:p>
            <a:pPr marL="0" indent="0">
              <a:buNone/>
            </a:pPr>
            <a:r>
              <a:rPr lang="en-US" dirty="0"/>
              <a:t>Alkaline phosphatase				55 units/L</a:t>
            </a:r>
          </a:p>
          <a:p>
            <a:pPr marL="0" indent="0">
              <a:buNone/>
            </a:pPr>
            <a:r>
              <a:rPr lang="en-US" dirty="0"/>
              <a:t>Aspartate aminotransferase (AST)			95 units/L</a:t>
            </a:r>
          </a:p>
          <a:p>
            <a:pPr marL="0" indent="0">
              <a:buNone/>
            </a:pPr>
            <a:r>
              <a:rPr lang="en-US" dirty="0"/>
              <a:t>Alanine aminotransferase (ALT)			83 units/L</a:t>
            </a:r>
          </a:p>
          <a:p>
            <a:pPr marL="0" indent="0">
              <a:buNone/>
            </a:pPr>
            <a:r>
              <a:rPr lang="en-US" dirty="0"/>
              <a:t>Albumin					2.8 g/dL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0431208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92A243-B67C-4349-8DA2-7DDBC009CC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hosphorus 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9041AD-73CB-B542-A517-A81F56ABB2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2.6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</p:txBody>
      </p:sp>
    </p:spTree>
    <p:extLst>
      <p:ext uri="{BB962C8B-B14F-4D97-AF65-F5344CB8AC3E}">
        <p14:creationId xmlns:p14="http://schemas.microsoft.com/office/powerpoint/2010/main" val="31658170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8FA180-EF24-B743-B21C-9B956DF7C9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nger-stick blood glucos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127039-F316-184F-A4F7-B5D62AD456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93 mg/dL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46469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C64634-D2C7-5D48-8B8E-2C6C77F630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enous blood gas (VBG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F69796-ED2C-CF46-B4B0-03766EAF03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H						7.36</a:t>
            </a:r>
          </a:p>
          <a:p>
            <a:pPr marL="0" indent="0">
              <a:buNone/>
            </a:pPr>
            <a:r>
              <a:rPr lang="en-US" dirty="0"/>
              <a:t>PaCO2					61 mmHg</a:t>
            </a:r>
          </a:p>
          <a:p>
            <a:pPr marL="0" indent="0">
              <a:buNone/>
            </a:pPr>
            <a:r>
              <a:rPr lang="en-US" dirty="0"/>
              <a:t>PaO2						45 mmHg</a:t>
            </a:r>
          </a:p>
          <a:p>
            <a:pPr marL="0" indent="0">
              <a:buNone/>
            </a:pPr>
            <a:r>
              <a:rPr lang="en-US" dirty="0"/>
              <a:t>Bicarbonate (HCO</a:t>
            </a:r>
            <a:r>
              <a:rPr lang="en-US" baseline="-25000" dirty="0"/>
              <a:t>3</a:t>
            </a:r>
            <a:r>
              <a:rPr lang="en-US" dirty="0"/>
              <a:t>)			22 </a:t>
            </a:r>
            <a:r>
              <a:rPr lang="en-US" dirty="0" err="1"/>
              <a:t>mEq</a:t>
            </a:r>
            <a:r>
              <a:rPr lang="en-US" dirty="0"/>
              <a:t>/L 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698901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21937-C20F-6F46-803C-1D800985F5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alysis (UA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F1962D-518D-0C41-82CA-DCF7C895F8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62500" lnSpcReduction="20000"/>
          </a:bodyPr>
          <a:lstStyle/>
          <a:p>
            <a:pPr marL="0" indent="0">
              <a:buNone/>
            </a:pPr>
            <a:r>
              <a:rPr lang="en-US" dirty="0"/>
              <a:t>Color					yellow</a:t>
            </a:r>
          </a:p>
          <a:p>
            <a:pPr marL="0" indent="0">
              <a:buNone/>
            </a:pPr>
            <a:r>
              <a:rPr lang="en-US" dirty="0"/>
              <a:t>Appearance				clear</a:t>
            </a:r>
          </a:p>
          <a:p>
            <a:pPr marL="0" indent="0">
              <a:buNone/>
            </a:pPr>
            <a:r>
              <a:rPr lang="en-US" dirty="0"/>
              <a:t>Specific gravity				1.0</a:t>
            </a:r>
          </a:p>
          <a:p>
            <a:pPr marL="0" indent="0">
              <a:buNone/>
            </a:pPr>
            <a:r>
              <a:rPr lang="en-US" dirty="0"/>
              <a:t>pH					7.0</a:t>
            </a:r>
          </a:p>
          <a:p>
            <a:pPr marL="0" indent="0">
              <a:buNone/>
            </a:pPr>
            <a:r>
              <a:rPr lang="en-US" dirty="0"/>
              <a:t>Glucose					negative</a:t>
            </a:r>
          </a:p>
          <a:p>
            <a:pPr marL="0" indent="0">
              <a:buNone/>
            </a:pPr>
            <a:r>
              <a:rPr lang="en-US" dirty="0"/>
              <a:t>Bilirubin					negative</a:t>
            </a:r>
          </a:p>
          <a:p>
            <a:pPr marL="0" indent="0">
              <a:buNone/>
            </a:pPr>
            <a:r>
              <a:rPr lang="en-US" dirty="0"/>
              <a:t>Ketones					0</a:t>
            </a:r>
          </a:p>
          <a:p>
            <a:pPr marL="0" indent="0">
              <a:buNone/>
            </a:pPr>
            <a:r>
              <a:rPr lang="en-US" dirty="0"/>
              <a:t>Protein					2+</a:t>
            </a:r>
          </a:p>
          <a:p>
            <a:pPr marL="0" indent="0">
              <a:buNone/>
            </a:pPr>
            <a:r>
              <a:rPr lang="en-US" dirty="0"/>
              <a:t>Leukocyte esterase 				negative</a:t>
            </a:r>
          </a:p>
          <a:p>
            <a:pPr marL="0" indent="0">
              <a:buNone/>
            </a:pPr>
            <a:r>
              <a:rPr lang="en-US" dirty="0"/>
              <a:t>Nitrites					negative</a:t>
            </a:r>
          </a:p>
          <a:p>
            <a:pPr marL="0" indent="0">
              <a:buNone/>
            </a:pPr>
            <a:r>
              <a:rPr lang="en-US" dirty="0"/>
              <a:t>White blood cells (WBC)			0 WBCs/high powered field (HPF)</a:t>
            </a:r>
          </a:p>
          <a:p>
            <a:pPr marL="0" indent="0">
              <a:buNone/>
            </a:pPr>
            <a:r>
              <a:rPr lang="en-US" dirty="0"/>
              <a:t>Red blood cells (RBC)			0 RBCs/HPF</a:t>
            </a:r>
          </a:p>
          <a:p>
            <a:pPr marL="0" indent="0">
              <a:buNone/>
            </a:pPr>
            <a:r>
              <a:rPr lang="en-US" dirty="0"/>
              <a:t>Squamous epithelial cells			0-5 cells/HPF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91035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0C1FCE-29B5-F442-A16E-6EC9DDFF36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e drug scree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13E7E2-8F43-2F44-9775-AB3B1B1314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marL="0" indent="0">
              <a:buNone/>
            </a:pPr>
            <a:r>
              <a:rPr lang="en-US" dirty="0"/>
              <a:t>Amphetamine 				negative</a:t>
            </a:r>
          </a:p>
          <a:p>
            <a:pPr marL="0" indent="0">
              <a:buNone/>
            </a:pPr>
            <a:r>
              <a:rPr lang="en-US" dirty="0"/>
              <a:t>Barbiturate 					negative </a:t>
            </a:r>
          </a:p>
          <a:p>
            <a:pPr marL="0" indent="0">
              <a:buNone/>
            </a:pPr>
            <a:r>
              <a:rPr lang="en-US" dirty="0"/>
              <a:t>Benzodiazepine 				negative</a:t>
            </a:r>
          </a:p>
          <a:p>
            <a:pPr marL="0" indent="0">
              <a:buNone/>
            </a:pPr>
            <a:r>
              <a:rPr lang="en-US" dirty="0"/>
              <a:t>Cocaine 					negative</a:t>
            </a:r>
          </a:p>
          <a:p>
            <a:pPr marL="0" indent="0">
              <a:buNone/>
            </a:pPr>
            <a:r>
              <a:rPr lang="en-US" dirty="0"/>
              <a:t>Marijuana 					negative</a:t>
            </a:r>
          </a:p>
          <a:p>
            <a:pPr marL="0" indent="0">
              <a:buNone/>
            </a:pPr>
            <a:r>
              <a:rPr lang="en-US" dirty="0"/>
              <a:t>Methadone 					negative</a:t>
            </a:r>
          </a:p>
          <a:p>
            <a:pPr marL="0" indent="0">
              <a:buNone/>
            </a:pPr>
            <a:r>
              <a:rPr lang="en-US" dirty="0"/>
              <a:t>Methamphetamine				negative</a:t>
            </a:r>
          </a:p>
          <a:p>
            <a:pPr marL="0" indent="0">
              <a:buNone/>
            </a:pPr>
            <a:r>
              <a:rPr lang="en-US" dirty="0"/>
              <a:t>Opiate 					negative</a:t>
            </a:r>
          </a:p>
          <a:p>
            <a:pPr marL="0" indent="0">
              <a:buNone/>
            </a:pPr>
            <a:r>
              <a:rPr lang="en-US" dirty="0"/>
              <a:t>Phencyclidine 				negative</a:t>
            </a:r>
          </a:p>
          <a:p>
            <a:pPr marL="0" indent="0">
              <a:buNone/>
            </a:pPr>
            <a:r>
              <a:rPr lang="en-US" dirty="0"/>
              <a:t>Tricyclic antidepressants 			negative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79980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9BDB16-240E-E844-93A4-05201D6081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e pregnancy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4A7952-E79C-DA41-A92F-F974869061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ositive</a:t>
            </a:r>
          </a:p>
        </p:txBody>
      </p:sp>
    </p:spTree>
    <p:extLst>
      <p:ext uri="{BB962C8B-B14F-4D97-AF65-F5344CB8AC3E}">
        <p14:creationId xmlns:p14="http://schemas.microsoft.com/office/powerpoint/2010/main" val="36494640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DACE98-4A9B-D54C-9F0C-2E85A7D70A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agulation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943565-A3F0-A247-A608-C3247D194F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rothrombin time (PT) 			12.3 seconds</a:t>
            </a:r>
          </a:p>
          <a:p>
            <a:pPr marL="0" indent="0">
              <a:buNone/>
            </a:pPr>
            <a:r>
              <a:rPr lang="en-US" dirty="0"/>
              <a:t>Partial thromboplastin time (PTT) 	23.7 seconds</a:t>
            </a:r>
          </a:p>
          <a:p>
            <a:pPr marL="0" indent="0">
              <a:buNone/>
            </a:pPr>
            <a:r>
              <a:rPr lang="en-US" dirty="0"/>
              <a:t>INR 						1.1 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10562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2DA902-7514-AF48-A3CA-E4B19E2371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etal heart trac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755F4E-3CF2-3547-B74E-3ED04952A5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Baseline fetal heart rate 130bpm with decrease in fetal heart rate from baseline lasting 30 seconds. Each decrease in fetal heart rate occurs after each contraction concerning for late decelerations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  <p:pic>
        <p:nvPicPr>
          <p:cNvPr id="4" name="Picture 3" descr="A picture containing text, tennis&#10;&#10;Description automatically generated">
            <a:extLst>
              <a:ext uri="{FF2B5EF4-FFF2-40B4-BE49-F238E27FC236}">
                <a16:creationId xmlns:a16="http://schemas.microsoft.com/office/drawing/2014/main" id="{A9AB5B06-89B2-2848-A27A-265C91EEA27E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9700" y="3429000"/>
            <a:ext cx="9144000" cy="28829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720031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610</Words>
  <Application>Microsoft Macintosh PowerPoint</Application>
  <PresentationFormat>Widescreen</PresentationFormat>
  <Paragraphs>84</Paragraphs>
  <Slides>2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Arial</vt:lpstr>
      <vt:lpstr>Calibri</vt:lpstr>
      <vt:lpstr>Calibri Light</vt:lpstr>
      <vt:lpstr>Office Theme</vt:lpstr>
      <vt:lpstr>Complete blood count (CBC)</vt:lpstr>
      <vt:lpstr>Complete metabolic panel (CMP)</vt:lpstr>
      <vt:lpstr>Finger-stick blood glucose</vt:lpstr>
      <vt:lpstr>Venous blood gas (VBG)</vt:lpstr>
      <vt:lpstr>Urinalysis (UA)</vt:lpstr>
      <vt:lpstr>Urine drug screen</vt:lpstr>
      <vt:lpstr>Urine pregnancy </vt:lpstr>
      <vt:lpstr>Coagulation panel</vt:lpstr>
      <vt:lpstr>Fetal heart tracing</vt:lpstr>
      <vt:lpstr>Chest radiograph (CXR) </vt:lpstr>
      <vt:lpstr>Magnesium </vt:lpstr>
      <vt:lpstr>Brain computed tomography </vt:lpstr>
      <vt:lpstr>Uric Acid</vt:lpstr>
      <vt:lpstr>Haptaglobin</vt:lpstr>
      <vt:lpstr>Lactic acid</vt:lpstr>
      <vt:lpstr>Repeat Magnesium </vt:lpstr>
      <vt:lpstr>Repeat lactic acid</vt:lpstr>
      <vt:lpstr>Arrival electrocardiogram (EKG)</vt:lpstr>
      <vt:lpstr>Post-magnesium electrocardiogram (EKG)</vt:lpstr>
      <vt:lpstr>Phosphorus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plete blood count (CBC)</dc:title>
  <dc:creator>Cheyenne Low</dc:creator>
  <cp:lastModifiedBy>Cheyenne Low</cp:lastModifiedBy>
  <cp:revision>20</cp:revision>
  <dcterms:created xsi:type="dcterms:W3CDTF">2021-07-24T03:39:19Z</dcterms:created>
  <dcterms:modified xsi:type="dcterms:W3CDTF">2021-07-24T03:49:23Z</dcterms:modified>
</cp:coreProperties>
</file>